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6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2514" y="2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980519-CD64-495F-A34B-5765753270A1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46366D-CC56-424E-9B50-1BA3D25BB9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8989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563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874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323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079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757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100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672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450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831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03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12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30CC7-F1C2-48E1-B786-1DEC7F5B8F3E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00023-0DA6-452B-AEBF-E8819483E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773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9DC31EB2-71F2-45C0-A4CD-BA8ED8940B98}"/>
              </a:ext>
            </a:extLst>
          </p:cNvPr>
          <p:cNvSpPr txBox="1"/>
          <p:nvPr/>
        </p:nvSpPr>
        <p:spPr>
          <a:xfrm>
            <a:off x="49505" y="5594663"/>
            <a:ext cx="6758989" cy="8694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upplemental Figure 3 Toxicity of p53 monomer, oligomer, fibril, and mixtures in primary neurons by LDH Assay</a:t>
            </a:r>
          </a:p>
          <a:p>
            <a:r>
              <a:rPr lang="en-US" sz="1000" b="1" dirty="0"/>
              <a:t>(A) </a:t>
            </a:r>
            <a:r>
              <a:rPr lang="en-US" sz="1000" dirty="0"/>
              <a:t>C57BL/6 primary neurons (n=2) treated with 0.5 µM and </a:t>
            </a:r>
            <a:r>
              <a:rPr lang="en-US" sz="1000" b="1" dirty="0"/>
              <a:t>(B)</a:t>
            </a:r>
            <a:r>
              <a:rPr lang="en-US" sz="1000" dirty="0"/>
              <a:t> 1 µM p53 monomer, p53 oligomer, p53 fibril, and p53 mixtures (each p53 treatment performed in triplicate) show no toxicity by LDH assay</a:t>
            </a:r>
            <a:r>
              <a:rPr lang="en-US" sz="1000" b="1" dirty="0"/>
              <a:t> (C)</a:t>
            </a:r>
            <a:r>
              <a:rPr lang="en-US" sz="1000" dirty="0"/>
              <a:t> Tau KO primary neurons (n=1) treated with 0.5 µM and </a:t>
            </a:r>
            <a:r>
              <a:rPr lang="en-US" sz="1000" b="1" dirty="0"/>
              <a:t>(D)</a:t>
            </a:r>
            <a:r>
              <a:rPr lang="en-US" sz="1000" dirty="0"/>
              <a:t> 1 µM p53 monomer, p53 oligomer, p53 fibril, and p53 mixtures (each p53 treatment performed in triplicate) show no toxicity by LDH assay.</a:t>
            </a:r>
            <a:r>
              <a:rPr lang="en-US" sz="1000" b="1" dirty="0"/>
              <a:t>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BAF431F-CB02-4950-B6C0-22CB6386078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761112" y="842811"/>
          <a:ext cx="1583611" cy="19653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8" r:id="rId3" imgW="2620708" imgH="3252191" progId="Prism8.Document">
                  <p:embed/>
                </p:oleObj>
              </mc:Choice>
              <mc:Fallback>
                <p:oleObj name="Prism 8" r:id="rId3" imgW="2620708" imgH="3252191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BAF431F-CB02-4950-B6C0-22CB638607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61112" y="842811"/>
                        <a:ext cx="1583611" cy="19653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CF38B8B-B65D-4445-883B-7741F88F137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06447" y="844877"/>
          <a:ext cx="1584090" cy="1965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8" r:id="rId5" imgW="2620708" imgH="3252191" progId="Prism8.Document">
                  <p:embed/>
                </p:oleObj>
              </mc:Choice>
              <mc:Fallback>
                <p:oleObj name="Prism 8" r:id="rId5" imgW="2620708" imgH="3252191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CF38B8B-B65D-4445-883B-7741F88F13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06447" y="844877"/>
                        <a:ext cx="1584090" cy="1965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B90009B-A363-4D68-8A42-624C7AC545B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06447" y="3072928"/>
          <a:ext cx="1584090" cy="1965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8" r:id="rId7" imgW="2620708" imgH="3252191" progId="Prism8.Document">
                  <p:embed/>
                </p:oleObj>
              </mc:Choice>
              <mc:Fallback>
                <p:oleObj name="Prism 8" r:id="rId7" imgW="2620708" imgH="3252191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CB90009B-A363-4D68-8A42-624C7AC545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06447" y="3072928"/>
                        <a:ext cx="1584090" cy="1965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079B7F5-0830-49E0-AE2B-C2858FFAFF5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760633" y="3072928"/>
          <a:ext cx="1584090" cy="1965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8" r:id="rId9" imgW="2620708" imgH="3252191" progId="Prism8.Document">
                  <p:embed/>
                </p:oleObj>
              </mc:Choice>
              <mc:Fallback>
                <p:oleObj name="Prism 8" r:id="rId9" imgW="2620708" imgH="3252191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079B7F5-0830-49E0-AE2B-C2858FFAFF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60633" y="3072928"/>
                        <a:ext cx="1584090" cy="1965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CABC5B33-2FCA-4779-9AFB-B1CD5373BACD}"/>
              </a:ext>
            </a:extLst>
          </p:cNvPr>
          <p:cNvSpPr txBox="1"/>
          <p:nvPr/>
        </p:nvSpPr>
        <p:spPr>
          <a:xfrm>
            <a:off x="1749095" y="68805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CD4E964-DA60-4E0F-8303-8314ABF338E9}"/>
              </a:ext>
            </a:extLst>
          </p:cNvPr>
          <p:cNvSpPr txBox="1"/>
          <p:nvPr/>
        </p:nvSpPr>
        <p:spPr>
          <a:xfrm>
            <a:off x="3510652" y="68154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329575E-0C27-4735-86C3-F3050CCE11C7}"/>
              </a:ext>
            </a:extLst>
          </p:cNvPr>
          <p:cNvSpPr txBox="1"/>
          <p:nvPr/>
        </p:nvSpPr>
        <p:spPr>
          <a:xfrm>
            <a:off x="1753259" y="2935762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7981D6-835E-4FF2-9AF3-C03B64B9B3C4}"/>
              </a:ext>
            </a:extLst>
          </p:cNvPr>
          <p:cNvSpPr txBox="1"/>
          <p:nvPr/>
        </p:nvSpPr>
        <p:spPr>
          <a:xfrm>
            <a:off x="3512577" y="2932244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52595245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1" id="{36359314-4BC1-461A-B4F5-B9A4FFC085CC}" vid="{AA6ADCFB-6C6C-494C-9895-DA45A1B554C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4</TotalTime>
  <Words>122</Words>
  <Application>Microsoft Office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eme1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right, Eric J.</dc:creator>
  <cp:lastModifiedBy>Wright, Eric J.</cp:lastModifiedBy>
  <cp:revision>3</cp:revision>
  <dcterms:created xsi:type="dcterms:W3CDTF">2020-07-30T07:01:19Z</dcterms:created>
  <dcterms:modified xsi:type="dcterms:W3CDTF">2020-07-30T07:05:31Z</dcterms:modified>
</cp:coreProperties>
</file>